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7B564-3AD9-4141-BDBF-B4FDC9A0C1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8C66F-B727-4EB4-851E-3F2DA4685D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4BFE6-5F8D-49DC-8EAB-FB8F437B44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C397A-D9B3-476D-B937-17AC7F8327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CFEC3-8AD2-46B3-9A64-F8F0CCB69B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63729-1603-4D6D-8913-DCAD0983EC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C5640-E2D6-4952-B78E-98F84A5348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409E5-A742-4BEC-919E-DA81637532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D826B-79BC-4EDE-B066-553B4EC7FB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895E6-B44D-42ED-ADBB-2C666DD15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D8835-5AB8-4286-9D73-73E037D33E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6767D-166A-45DD-9019-F105BB2F65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833A5A1-86E7-4F00-B8C7-925FE6189DC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444600" y="1316520"/>
            <a:ext cx="1778040" cy="2883600"/>
            <a:chOff x="444600" y="1316520"/>
            <a:chExt cx="1778040" cy="2883600"/>
          </a:xfrm>
        </p:grpSpPr>
        <p:pic>
          <p:nvPicPr>
            <p:cNvPr id="42" name="Picture 3" descr="Nus690K+GSTXA21.071012a.jpg"/>
            <p:cNvPicPr/>
            <p:nvPr/>
          </p:nvPicPr>
          <p:blipFill>
            <a:blip r:embed="rId1"/>
            <a:srcRect l="0" t="-637" r="78599" b="0"/>
            <a:stretch/>
          </p:blipFill>
          <p:spPr>
            <a:xfrm>
              <a:off x="444600" y="2322360"/>
              <a:ext cx="783000" cy="152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HNus690K+GSTXA21.jpg"/>
            <p:cNvPicPr/>
            <p:nvPr/>
          </p:nvPicPr>
          <p:blipFill>
            <a:blip r:embed="rId2"/>
            <a:srcRect l="0" t="0" r="78600" b="0"/>
            <a:stretch/>
          </p:blipFill>
          <p:spPr>
            <a:xfrm>
              <a:off x="1233360" y="2330640"/>
              <a:ext cx="764640" cy="154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44"/>
            <p:cNvSpPr/>
            <p:nvPr/>
          </p:nvSpPr>
          <p:spPr>
            <a:xfrm rot="16200000">
              <a:off x="210600" y="1739880"/>
              <a:ext cx="90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mbria"/>
                  <a:ea typeface="Cambria"/>
                </a:rPr>
                <a:t>Nus:CRK6K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45"/>
            <p:cNvSpPr/>
            <p:nvPr/>
          </p:nvSpPr>
          <p:spPr>
            <a:xfrm rot="16200000">
              <a:off x="497520" y="1683000"/>
              <a:ext cx="100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mbria"/>
                  <a:ea typeface="Cambria"/>
                </a:rPr>
                <a:t>Nus:CRK6D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44"/>
            <p:cNvSpPr/>
            <p:nvPr/>
          </p:nvSpPr>
          <p:spPr>
            <a:xfrm rot="16200000">
              <a:off x="1015200" y="1739880"/>
              <a:ext cx="90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mbria"/>
                  <a:ea typeface="Cambria"/>
                </a:rPr>
                <a:t>Nus:CRK6K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45"/>
            <p:cNvSpPr/>
            <p:nvPr/>
          </p:nvSpPr>
          <p:spPr>
            <a:xfrm rot="16200000">
              <a:off x="1302120" y="1683000"/>
              <a:ext cx="100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mbria"/>
                  <a:ea typeface="Cambria"/>
                </a:rPr>
                <a:t>Nus:CRK6D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2"/>
            <p:cNvSpPr/>
            <p:nvPr/>
          </p:nvSpPr>
          <p:spPr>
            <a:xfrm>
              <a:off x="508680" y="3817440"/>
              <a:ext cx="584640" cy="382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137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Kinas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1137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ssa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66"/>
            <p:cNvSpPr/>
            <p:nvPr/>
          </p:nvSpPr>
          <p:spPr>
            <a:xfrm>
              <a:off x="1223640" y="3808800"/>
              <a:ext cx="999000" cy="382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ts val="1137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oomassie blue staini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" name="Rectangle 3"/>
          <p:cNvSpPr/>
          <p:nvPr/>
        </p:nvSpPr>
        <p:spPr>
          <a:xfrm>
            <a:off x="2502000" y="1320840"/>
            <a:ext cx="5994360" cy="359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  1 IQSIDSLILDLPTIRVATDDFADTKMIGQGGFGMVYKGVLPDGQEIAVKRLCQSSRQGIG  60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+QS  SL+LDL T+R ATD+F++ K +G+GGFG+VYKG LP+GQEIAVKRL Q+SRQGI 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  1 MQSFASLVLDLQTLRTATDNFSEHKRLGEGGFGVVYKGDLPEGQEIAVKRLAQTSRQGIE  60 </a:t>
            </a:r>
            <a:br>
              <a:rPr sz="1000"/>
            </a:b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 61 ELKSELILVAKLYHKNLVRLIGVCLEQQEKILVYEYMPNGSLDIVLFDTDKNRELDWGKR 120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ELK+EL+LVAKL H NLVRLIGVCLE+ EKIL YEYMPN SLD +LFD ++ +ELDWG+R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 61 ELKTELLLVAKLNHNNLVRLIGVCLEENEKILAYEYMPNRSLDTILFDAERIKELDWGQR 120 </a:t>
            </a:r>
            <a:br>
              <a:rPr sz="1000"/>
            </a:b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121 FKIINGIARGLQYLHEDSQLKIVHRDLKASNILLDFDYSPKISDFGLAKIFGGDQSEDVT 180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FKIINGIARGLQYLHEDSQLKIVHRDLKASN+LLD  Y+PKISDFGLAKIF  DQS+ +T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121 FKIINGIARGLQYLHEDSQLKIVHRDLKASNVLLDSAYNPKISDFGLAKIFERDQSQVIT 180 </a:t>
            </a:r>
            <a:br>
              <a:rPr sz="1000"/>
            </a:b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181 NRIAGTYGYMAPEYAMRGNYSIKSDVFSFGVLVLEIITGRRNTGSYDSGQDVDLLNLVWE 240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+RIAGTYGYM+PEYAMRG YS+K DV+SFGVLVLEIITGRRN GSY S   VDL+ + WE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181 HRIAGTYGYMSPEYAMRGQYSMKLDVYSFGVLVLEIITGRRNFGSYGSDHVVDLIYVTWE 240 </a:t>
            </a:r>
            <a:br>
              <a:rPr sz="1000"/>
            </a:b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241 HWTRGNVVELIDPSMGDHPPIEQMLKCIHIGLLCVQKKPASRPTISSVNIMLSS-NTVRL 299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HWT    +ELIDPS+G+H P++++LKCIHIGLLCVQ KPA RP +S+VN MLSS  TVRL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241 HWTSDKAIELIDPSLGNHYPVDKVLKCIHIGLLCVQPKPADRPLMSAVNAMLSSTGTVRL 300 </a:t>
            </a:r>
            <a:br>
              <a:rPr sz="1000"/>
            </a:b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6  300 PSLSRPAFCIQEVSASDSSNPYSERYPRPRHSGYSDNSTVVSSNDLSITELVPR 353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          P LSRP+F +QE+ A+ S                                         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ÇlÇr ñæí©"/>
              </a:rPr>
              <a:t>CRK10 301 PCLSRPSFWVQEIGATAS------------------------------------ 318 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320400" y="86364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6"/>
          <p:cNvSpPr/>
          <p:nvPr/>
        </p:nvSpPr>
        <p:spPr>
          <a:xfrm>
            <a:off x="2495880" y="8636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"/>
          <p:cNvSpPr/>
          <p:nvPr/>
        </p:nvSpPr>
        <p:spPr>
          <a:xfrm>
            <a:off x="155160" y="6464160"/>
            <a:ext cx="61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33:56Z</dcterms:created>
  <dc:creator>Mawsheng Chern</dc:creator>
  <dc:description/>
  <dc:language>en-US</dc:language>
  <cp:lastModifiedBy>Mawsheng Chern</cp:lastModifiedBy>
  <dcterms:modified xsi:type="dcterms:W3CDTF">2016-04-19T17:34:24Z</dcterms:modified>
  <cp:revision>1</cp:revision>
  <dc:subject/>
  <dc:title>PowerPoint Presentation</dc:title>
</cp:coreProperties>
</file>